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3" r:id="rId2"/>
  </p:sldIdLst>
  <p:sldSz cx="16200438" cy="11158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68" userDrawn="1">
          <p15:clr>
            <a:srgbClr val="A4A3A4"/>
          </p15:clr>
        </p15:guide>
        <p15:guide id="2" pos="501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785" autoAdjust="0"/>
    <p:restoredTop sz="94660"/>
  </p:normalViewPr>
  <p:slideViewPr>
    <p:cSldViewPr snapToGrid="0" showGuides="1">
      <p:cViewPr>
        <p:scale>
          <a:sx n="25" d="100"/>
          <a:sy n="25" d="100"/>
        </p:scale>
        <p:origin x="2132" y="664"/>
      </p:cViewPr>
      <p:guideLst>
        <p:guide orient="horz" pos="3468"/>
        <p:guide pos="501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5033" y="1826178"/>
            <a:ext cx="13770372" cy="3884824"/>
          </a:xfrm>
        </p:spPr>
        <p:txBody>
          <a:bodyPr anchor="b"/>
          <a:lstStyle>
            <a:lvl1pPr algn="ctr">
              <a:defRPr sz="9763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25055" y="5860816"/>
            <a:ext cx="12150329" cy="2694063"/>
          </a:xfrm>
        </p:spPr>
        <p:txBody>
          <a:bodyPr/>
          <a:lstStyle>
            <a:lvl1pPr marL="0" indent="0" algn="ctr">
              <a:buNone/>
              <a:defRPr sz="3905"/>
            </a:lvl1pPr>
            <a:lvl2pPr marL="743910" indent="0" algn="ctr">
              <a:buNone/>
              <a:defRPr sz="3254"/>
            </a:lvl2pPr>
            <a:lvl3pPr marL="1487820" indent="0" algn="ctr">
              <a:buNone/>
              <a:defRPr sz="2929"/>
            </a:lvl3pPr>
            <a:lvl4pPr marL="2231730" indent="0" algn="ctr">
              <a:buNone/>
              <a:defRPr sz="2603"/>
            </a:lvl4pPr>
            <a:lvl5pPr marL="2975640" indent="0" algn="ctr">
              <a:buNone/>
              <a:defRPr sz="2603"/>
            </a:lvl5pPr>
            <a:lvl6pPr marL="3719551" indent="0" algn="ctr">
              <a:buNone/>
              <a:defRPr sz="2603"/>
            </a:lvl6pPr>
            <a:lvl7pPr marL="4463461" indent="0" algn="ctr">
              <a:buNone/>
              <a:defRPr sz="2603"/>
            </a:lvl7pPr>
            <a:lvl8pPr marL="5207371" indent="0" algn="ctr">
              <a:buNone/>
              <a:defRPr sz="2603"/>
            </a:lvl8pPr>
            <a:lvl9pPr marL="5951281" indent="0" algn="ctr">
              <a:buNone/>
              <a:defRPr sz="2603"/>
            </a:lvl9pPr>
          </a:lstStyle>
          <a:p>
            <a:r>
              <a:rPr lang="ru-RU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B0942-76A7-49AF-9B15-B45DFB255D3E}" type="datetimeFigureOut">
              <a:rPr lang="ru-RU" smtClean="0"/>
              <a:t>22.01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DCB2-A86F-4AF2-8122-20C6B304EA6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90532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B0942-76A7-49AF-9B15-B45DFB255D3E}" type="datetimeFigureOut">
              <a:rPr lang="ru-RU" smtClean="0"/>
              <a:t>22.01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DCB2-A86F-4AF2-8122-20C6B304EA6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01072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593440" y="594089"/>
            <a:ext cx="3493219" cy="9456345"/>
          </a:xfrm>
        </p:spPr>
        <p:txBody>
          <a:bodyPr vert="eaVert"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3781" y="594089"/>
            <a:ext cx="10277153" cy="9456345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B0942-76A7-49AF-9B15-B45DFB255D3E}" type="datetimeFigureOut">
              <a:rPr lang="ru-RU" smtClean="0"/>
              <a:t>22.01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DCB2-A86F-4AF2-8122-20C6B304EA6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12414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B0942-76A7-49AF-9B15-B45DFB255D3E}" type="datetimeFigureOut">
              <a:rPr lang="ru-RU" smtClean="0"/>
              <a:t>22.01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DCB2-A86F-4AF2-8122-20C6B304EA6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12765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5343" y="2781889"/>
            <a:ext cx="13972878" cy="4641641"/>
          </a:xfrm>
        </p:spPr>
        <p:txBody>
          <a:bodyPr anchor="b"/>
          <a:lstStyle>
            <a:lvl1pPr>
              <a:defRPr sz="9763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5343" y="7467442"/>
            <a:ext cx="13972878" cy="2440929"/>
          </a:xfrm>
        </p:spPr>
        <p:txBody>
          <a:bodyPr/>
          <a:lstStyle>
            <a:lvl1pPr marL="0" indent="0">
              <a:buNone/>
              <a:defRPr sz="3905">
                <a:solidFill>
                  <a:schemeClr val="tx1"/>
                </a:solidFill>
              </a:defRPr>
            </a:lvl1pPr>
            <a:lvl2pPr marL="743910" indent="0">
              <a:buNone/>
              <a:defRPr sz="3254">
                <a:solidFill>
                  <a:schemeClr val="tx1">
                    <a:tint val="75000"/>
                  </a:schemeClr>
                </a:solidFill>
              </a:defRPr>
            </a:lvl2pPr>
            <a:lvl3pPr marL="1487820" indent="0">
              <a:buNone/>
              <a:defRPr sz="2929">
                <a:solidFill>
                  <a:schemeClr val="tx1">
                    <a:tint val="75000"/>
                  </a:schemeClr>
                </a:solidFill>
              </a:defRPr>
            </a:lvl3pPr>
            <a:lvl4pPr marL="2231730" indent="0">
              <a:buNone/>
              <a:defRPr sz="2603">
                <a:solidFill>
                  <a:schemeClr val="tx1">
                    <a:tint val="75000"/>
                  </a:schemeClr>
                </a:solidFill>
              </a:defRPr>
            </a:lvl4pPr>
            <a:lvl5pPr marL="2975640" indent="0">
              <a:buNone/>
              <a:defRPr sz="2603">
                <a:solidFill>
                  <a:schemeClr val="tx1">
                    <a:tint val="75000"/>
                  </a:schemeClr>
                </a:solidFill>
              </a:defRPr>
            </a:lvl5pPr>
            <a:lvl6pPr marL="3719551" indent="0">
              <a:buNone/>
              <a:defRPr sz="2603">
                <a:solidFill>
                  <a:schemeClr val="tx1">
                    <a:tint val="75000"/>
                  </a:schemeClr>
                </a:solidFill>
              </a:defRPr>
            </a:lvl6pPr>
            <a:lvl7pPr marL="4463461" indent="0">
              <a:buNone/>
              <a:defRPr sz="2603">
                <a:solidFill>
                  <a:schemeClr val="tx1">
                    <a:tint val="75000"/>
                  </a:schemeClr>
                </a:solidFill>
              </a:defRPr>
            </a:lvl7pPr>
            <a:lvl8pPr marL="5207371" indent="0">
              <a:buNone/>
              <a:defRPr sz="2603">
                <a:solidFill>
                  <a:schemeClr val="tx1">
                    <a:tint val="75000"/>
                  </a:schemeClr>
                </a:solidFill>
              </a:defRPr>
            </a:lvl8pPr>
            <a:lvl9pPr marL="5951281" indent="0">
              <a:buNone/>
              <a:defRPr sz="26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B0942-76A7-49AF-9B15-B45DFB255D3E}" type="datetimeFigureOut">
              <a:rPr lang="ru-RU" smtClean="0"/>
              <a:t>22.01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DCB2-A86F-4AF2-8122-20C6B304EA6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36288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3780" y="2970444"/>
            <a:ext cx="6885186" cy="7079990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01472" y="2970444"/>
            <a:ext cx="6885186" cy="7079990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B0942-76A7-49AF-9B15-B45DFB255D3E}" type="datetimeFigureOut">
              <a:rPr lang="ru-RU" smtClean="0"/>
              <a:t>22.01.2025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DCB2-A86F-4AF2-8122-20C6B304EA6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28188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594091"/>
            <a:ext cx="13972878" cy="2156802"/>
          </a:xfrm>
        </p:spPr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892" y="2735392"/>
            <a:ext cx="6853544" cy="1340574"/>
          </a:xfrm>
        </p:spPr>
        <p:txBody>
          <a:bodyPr anchor="b"/>
          <a:lstStyle>
            <a:lvl1pPr marL="0" indent="0">
              <a:buNone/>
              <a:defRPr sz="3905" b="1"/>
            </a:lvl1pPr>
            <a:lvl2pPr marL="743910" indent="0">
              <a:buNone/>
              <a:defRPr sz="3254" b="1"/>
            </a:lvl2pPr>
            <a:lvl3pPr marL="1487820" indent="0">
              <a:buNone/>
              <a:defRPr sz="2929" b="1"/>
            </a:lvl3pPr>
            <a:lvl4pPr marL="2231730" indent="0">
              <a:buNone/>
              <a:defRPr sz="2603" b="1"/>
            </a:lvl4pPr>
            <a:lvl5pPr marL="2975640" indent="0">
              <a:buNone/>
              <a:defRPr sz="2603" b="1"/>
            </a:lvl5pPr>
            <a:lvl6pPr marL="3719551" indent="0">
              <a:buNone/>
              <a:defRPr sz="2603" b="1"/>
            </a:lvl6pPr>
            <a:lvl7pPr marL="4463461" indent="0">
              <a:buNone/>
              <a:defRPr sz="2603" b="1"/>
            </a:lvl7pPr>
            <a:lvl8pPr marL="5207371" indent="0">
              <a:buNone/>
              <a:defRPr sz="2603" b="1"/>
            </a:lvl8pPr>
            <a:lvl9pPr marL="5951281" indent="0">
              <a:buNone/>
              <a:defRPr sz="2603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5892" y="4075966"/>
            <a:ext cx="6853544" cy="5995132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01473" y="2735392"/>
            <a:ext cx="6887296" cy="1340574"/>
          </a:xfrm>
        </p:spPr>
        <p:txBody>
          <a:bodyPr anchor="b"/>
          <a:lstStyle>
            <a:lvl1pPr marL="0" indent="0">
              <a:buNone/>
              <a:defRPr sz="3905" b="1"/>
            </a:lvl1pPr>
            <a:lvl2pPr marL="743910" indent="0">
              <a:buNone/>
              <a:defRPr sz="3254" b="1"/>
            </a:lvl2pPr>
            <a:lvl3pPr marL="1487820" indent="0">
              <a:buNone/>
              <a:defRPr sz="2929" b="1"/>
            </a:lvl3pPr>
            <a:lvl4pPr marL="2231730" indent="0">
              <a:buNone/>
              <a:defRPr sz="2603" b="1"/>
            </a:lvl4pPr>
            <a:lvl5pPr marL="2975640" indent="0">
              <a:buNone/>
              <a:defRPr sz="2603" b="1"/>
            </a:lvl5pPr>
            <a:lvl6pPr marL="3719551" indent="0">
              <a:buNone/>
              <a:defRPr sz="2603" b="1"/>
            </a:lvl6pPr>
            <a:lvl7pPr marL="4463461" indent="0">
              <a:buNone/>
              <a:defRPr sz="2603" b="1"/>
            </a:lvl7pPr>
            <a:lvl8pPr marL="5207371" indent="0">
              <a:buNone/>
              <a:defRPr sz="2603" b="1"/>
            </a:lvl8pPr>
            <a:lvl9pPr marL="5951281" indent="0">
              <a:buNone/>
              <a:defRPr sz="2603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01473" y="4075966"/>
            <a:ext cx="6887296" cy="5995132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B0942-76A7-49AF-9B15-B45DFB255D3E}" type="datetimeFigureOut">
              <a:rPr lang="ru-RU" smtClean="0"/>
              <a:t>22.01.2025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DCB2-A86F-4AF2-8122-20C6B304EA6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939302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B0942-76A7-49AF-9B15-B45DFB255D3E}" type="datetimeFigureOut">
              <a:rPr lang="ru-RU" smtClean="0"/>
              <a:t>22.01.2025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DCB2-A86F-4AF2-8122-20C6B304EA6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66812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B0942-76A7-49AF-9B15-B45DFB255D3E}" type="datetimeFigureOut">
              <a:rPr lang="ru-RU" smtClean="0"/>
              <a:t>22.01.2025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DCB2-A86F-4AF2-8122-20C6B304EA6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9350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743902"/>
            <a:ext cx="5225063" cy="2603659"/>
          </a:xfrm>
        </p:spPr>
        <p:txBody>
          <a:bodyPr anchor="b"/>
          <a:lstStyle>
            <a:lvl1pPr>
              <a:defRPr sz="5207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887296" y="1606625"/>
            <a:ext cx="8201472" cy="7929794"/>
          </a:xfrm>
        </p:spPr>
        <p:txBody>
          <a:bodyPr/>
          <a:lstStyle>
            <a:lvl1pPr>
              <a:defRPr sz="5207"/>
            </a:lvl1pPr>
            <a:lvl2pPr>
              <a:defRPr sz="4556"/>
            </a:lvl2pPr>
            <a:lvl3pPr>
              <a:defRPr sz="3905"/>
            </a:lvl3pPr>
            <a:lvl4pPr>
              <a:defRPr sz="3254"/>
            </a:lvl4pPr>
            <a:lvl5pPr>
              <a:defRPr sz="3254"/>
            </a:lvl5pPr>
            <a:lvl6pPr>
              <a:defRPr sz="3254"/>
            </a:lvl6pPr>
            <a:lvl7pPr>
              <a:defRPr sz="3254"/>
            </a:lvl7pPr>
            <a:lvl8pPr>
              <a:defRPr sz="3254"/>
            </a:lvl8pPr>
            <a:lvl9pPr>
              <a:defRPr sz="3254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0" y="3347561"/>
            <a:ext cx="5225063" cy="6201772"/>
          </a:xfrm>
        </p:spPr>
        <p:txBody>
          <a:bodyPr/>
          <a:lstStyle>
            <a:lvl1pPr marL="0" indent="0">
              <a:buNone/>
              <a:defRPr sz="2603"/>
            </a:lvl1pPr>
            <a:lvl2pPr marL="743910" indent="0">
              <a:buNone/>
              <a:defRPr sz="2278"/>
            </a:lvl2pPr>
            <a:lvl3pPr marL="1487820" indent="0">
              <a:buNone/>
              <a:defRPr sz="1953"/>
            </a:lvl3pPr>
            <a:lvl4pPr marL="2231730" indent="0">
              <a:buNone/>
              <a:defRPr sz="1627"/>
            </a:lvl4pPr>
            <a:lvl5pPr marL="2975640" indent="0">
              <a:buNone/>
              <a:defRPr sz="1627"/>
            </a:lvl5pPr>
            <a:lvl6pPr marL="3719551" indent="0">
              <a:buNone/>
              <a:defRPr sz="1627"/>
            </a:lvl6pPr>
            <a:lvl7pPr marL="4463461" indent="0">
              <a:buNone/>
              <a:defRPr sz="1627"/>
            </a:lvl7pPr>
            <a:lvl8pPr marL="5207371" indent="0">
              <a:buNone/>
              <a:defRPr sz="1627"/>
            </a:lvl8pPr>
            <a:lvl9pPr marL="5951281" indent="0">
              <a:buNone/>
              <a:defRPr sz="1627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B0942-76A7-49AF-9B15-B45DFB255D3E}" type="datetimeFigureOut">
              <a:rPr lang="ru-RU" smtClean="0"/>
              <a:t>22.01.2025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DCB2-A86F-4AF2-8122-20C6B304EA6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986925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743902"/>
            <a:ext cx="5225063" cy="2603659"/>
          </a:xfrm>
        </p:spPr>
        <p:txBody>
          <a:bodyPr anchor="b"/>
          <a:lstStyle>
            <a:lvl1pPr>
              <a:defRPr sz="5207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887296" y="1606625"/>
            <a:ext cx="8201472" cy="7929794"/>
          </a:xfrm>
        </p:spPr>
        <p:txBody>
          <a:bodyPr anchor="t"/>
          <a:lstStyle>
            <a:lvl1pPr marL="0" indent="0">
              <a:buNone/>
              <a:defRPr sz="5207"/>
            </a:lvl1pPr>
            <a:lvl2pPr marL="743910" indent="0">
              <a:buNone/>
              <a:defRPr sz="4556"/>
            </a:lvl2pPr>
            <a:lvl3pPr marL="1487820" indent="0">
              <a:buNone/>
              <a:defRPr sz="3905"/>
            </a:lvl3pPr>
            <a:lvl4pPr marL="2231730" indent="0">
              <a:buNone/>
              <a:defRPr sz="3254"/>
            </a:lvl4pPr>
            <a:lvl5pPr marL="2975640" indent="0">
              <a:buNone/>
              <a:defRPr sz="3254"/>
            </a:lvl5pPr>
            <a:lvl6pPr marL="3719551" indent="0">
              <a:buNone/>
              <a:defRPr sz="3254"/>
            </a:lvl6pPr>
            <a:lvl7pPr marL="4463461" indent="0">
              <a:buNone/>
              <a:defRPr sz="3254"/>
            </a:lvl7pPr>
            <a:lvl8pPr marL="5207371" indent="0">
              <a:buNone/>
              <a:defRPr sz="3254"/>
            </a:lvl8pPr>
            <a:lvl9pPr marL="5951281" indent="0">
              <a:buNone/>
              <a:defRPr sz="3254"/>
            </a:lvl9pPr>
          </a:lstStyle>
          <a:p>
            <a:r>
              <a:rPr lang="ru-RU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0" y="3347561"/>
            <a:ext cx="5225063" cy="6201772"/>
          </a:xfrm>
        </p:spPr>
        <p:txBody>
          <a:bodyPr/>
          <a:lstStyle>
            <a:lvl1pPr marL="0" indent="0">
              <a:buNone/>
              <a:defRPr sz="2603"/>
            </a:lvl1pPr>
            <a:lvl2pPr marL="743910" indent="0">
              <a:buNone/>
              <a:defRPr sz="2278"/>
            </a:lvl2pPr>
            <a:lvl3pPr marL="1487820" indent="0">
              <a:buNone/>
              <a:defRPr sz="1953"/>
            </a:lvl3pPr>
            <a:lvl4pPr marL="2231730" indent="0">
              <a:buNone/>
              <a:defRPr sz="1627"/>
            </a:lvl4pPr>
            <a:lvl5pPr marL="2975640" indent="0">
              <a:buNone/>
              <a:defRPr sz="1627"/>
            </a:lvl5pPr>
            <a:lvl6pPr marL="3719551" indent="0">
              <a:buNone/>
              <a:defRPr sz="1627"/>
            </a:lvl6pPr>
            <a:lvl7pPr marL="4463461" indent="0">
              <a:buNone/>
              <a:defRPr sz="1627"/>
            </a:lvl7pPr>
            <a:lvl8pPr marL="5207371" indent="0">
              <a:buNone/>
              <a:defRPr sz="1627"/>
            </a:lvl8pPr>
            <a:lvl9pPr marL="5951281" indent="0">
              <a:buNone/>
              <a:defRPr sz="1627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B0942-76A7-49AF-9B15-B45DFB255D3E}" type="datetimeFigureOut">
              <a:rPr lang="ru-RU" smtClean="0"/>
              <a:t>22.01.2025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ADCB2-A86F-4AF2-8122-20C6B304EA6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971278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3780" y="594091"/>
            <a:ext cx="13972878" cy="2156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3780" y="2970444"/>
            <a:ext cx="13972878" cy="707999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3780" y="10342314"/>
            <a:ext cx="3645099" cy="5940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5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6B0942-76A7-49AF-9B15-B45DFB255D3E}" type="datetimeFigureOut">
              <a:rPr lang="ru-RU" smtClean="0"/>
              <a:t>22.01.2025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66395" y="10342314"/>
            <a:ext cx="5467648" cy="5940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5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41559" y="10342314"/>
            <a:ext cx="3645099" cy="5940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5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CADCB2-A86F-4AF2-8122-20C6B304EA6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288849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487820" rtl="0" eaLnBrk="1" latinLnBrk="0" hangingPunct="1">
        <a:lnSpc>
          <a:spcPct val="90000"/>
        </a:lnSpc>
        <a:spcBef>
          <a:spcPct val="0"/>
        </a:spcBef>
        <a:buNone/>
        <a:defRPr sz="715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1955" indent="-371955" algn="l" defTabSz="1487820" rtl="0" eaLnBrk="1" latinLnBrk="0" hangingPunct="1">
        <a:lnSpc>
          <a:spcPct val="90000"/>
        </a:lnSpc>
        <a:spcBef>
          <a:spcPts val="1627"/>
        </a:spcBef>
        <a:buFont typeface="Arial" panose="020B0604020202020204" pitchFamily="34" charset="0"/>
        <a:buChar char="•"/>
        <a:defRPr sz="4556" kern="1200">
          <a:solidFill>
            <a:schemeClr val="tx1"/>
          </a:solidFill>
          <a:latin typeface="+mn-lt"/>
          <a:ea typeface="+mn-ea"/>
          <a:cs typeface="+mn-cs"/>
        </a:defRPr>
      </a:lvl1pPr>
      <a:lvl2pPr marL="1115865" indent="-371955" algn="l" defTabSz="1487820" rtl="0" eaLnBrk="1" latinLnBrk="0" hangingPunct="1">
        <a:lnSpc>
          <a:spcPct val="90000"/>
        </a:lnSpc>
        <a:spcBef>
          <a:spcPts val="814"/>
        </a:spcBef>
        <a:buFont typeface="Arial" panose="020B0604020202020204" pitchFamily="34" charset="0"/>
        <a:buChar char="•"/>
        <a:defRPr sz="3905" kern="1200">
          <a:solidFill>
            <a:schemeClr val="tx1"/>
          </a:solidFill>
          <a:latin typeface="+mn-lt"/>
          <a:ea typeface="+mn-ea"/>
          <a:cs typeface="+mn-cs"/>
        </a:defRPr>
      </a:lvl2pPr>
      <a:lvl3pPr marL="1859775" indent="-371955" algn="l" defTabSz="1487820" rtl="0" eaLnBrk="1" latinLnBrk="0" hangingPunct="1">
        <a:lnSpc>
          <a:spcPct val="90000"/>
        </a:lnSpc>
        <a:spcBef>
          <a:spcPts val="814"/>
        </a:spcBef>
        <a:buFont typeface="Arial" panose="020B0604020202020204" pitchFamily="34" charset="0"/>
        <a:buChar char="•"/>
        <a:defRPr sz="3254" kern="1200">
          <a:solidFill>
            <a:schemeClr val="tx1"/>
          </a:solidFill>
          <a:latin typeface="+mn-lt"/>
          <a:ea typeface="+mn-ea"/>
          <a:cs typeface="+mn-cs"/>
        </a:defRPr>
      </a:lvl3pPr>
      <a:lvl4pPr marL="2603685" indent="-371955" algn="l" defTabSz="1487820" rtl="0" eaLnBrk="1" latinLnBrk="0" hangingPunct="1">
        <a:lnSpc>
          <a:spcPct val="90000"/>
        </a:lnSpc>
        <a:spcBef>
          <a:spcPts val="814"/>
        </a:spcBef>
        <a:buFont typeface="Arial" panose="020B0604020202020204" pitchFamily="34" charset="0"/>
        <a:buChar char="•"/>
        <a:defRPr sz="2929" kern="1200">
          <a:solidFill>
            <a:schemeClr val="tx1"/>
          </a:solidFill>
          <a:latin typeface="+mn-lt"/>
          <a:ea typeface="+mn-ea"/>
          <a:cs typeface="+mn-cs"/>
        </a:defRPr>
      </a:lvl4pPr>
      <a:lvl5pPr marL="3347596" indent="-371955" algn="l" defTabSz="1487820" rtl="0" eaLnBrk="1" latinLnBrk="0" hangingPunct="1">
        <a:lnSpc>
          <a:spcPct val="90000"/>
        </a:lnSpc>
        <a:spcBef>
          <a:spcPts val="814"/>
        </a:spcBef>
        <a:buFont typeface="Arial" panose="020B0604020202020204" pitchFamily="34" charset="0"/>
        <a:buChar char="•"/>
        <a:defRPr sz="2929" kern="1200">
          <a:solidFill>
            <a:schemeClr val="tx1"/>
          </a:solidFill>
          <a:latin typeface="+mn-lt"/>
          <a:ea typeface="+mn-ea"/>
          <a:cs typeface="+mn-cs"/>
        </a:defRPr>
      </a:lvl5pPr>
      <a:lvl6pPr marL="4091506" indent="-371955" algn="l" defTabSz="1487820" rtl="0" eaLnBrk="1" latinLnBrk="0" hangingPunct="1">
        <a:lnSpc>
          <a:spcPct val="90000"/>
        </a:lnSpc>
        <a:spcBef>
          <a:spcPts val="814"/>
        </a:spcBef>
        <a:buFont typeface="Arial" panose="020B0604020202020204" pitchFamily="34" charset="0"/>
        <a:buChar char="•"/>
        <a:defRPr sz="2929" kern="1200">
          <a:solidFill>
            <a:schemeClr val="tx1"/>
          </a:solidFill>
          <a:latin typeface="+mn-lt"/>
          <a:ea typeface="+mn-ea"/>
          <a:cs typeface="+mn-cs"/>
        </a:defRPr>
      </a:lvl6pPr>
      <a:lvl7pPr marL="4835416" indent="-371955" algn="l" defTabSz="1487820" rtl="0" eaLnBrk="1" latinLnBrk="0" hangingPunct="1">
        <a:lnSpc>
          <a:spcPct val="90000"/>
        </a:lnSpc>
        <a:spcBef>
          <a:spcPts val="814"/>
        </a:spcBef>
        <a:buFont typeface="Arial" panose="020B0604020202020204" pitchFamily="34" charset="0"/>
        <a:buChar char="•"/>
        <a:defRPr sz="2929" kern="1200">
          <a:solidFill>
            <a:schemeClr val="tx1"/>
          </a:solidFill>
          <a:latin typeface="+mn-lt"/>
          <a:ea typeface="+mn-ea"/>
          <a:cs typeface="+mn-cs"/>
        </a:defRPr>
      </a:lvl7pPr>
      <a:lvl8pPr marL="5579326" indent="-371955" algn="l" defTabSz="1487820" rtl="0" eaLnBrk="1" latinLnBrk="0" hangingPunct="1">
        <a:lnSpc>
          <a:spcPct val="90000"/>
        </a:lnSpc>
        <a:spcBef>
          <a:spcPts val="814"/>
        </a:spcBef>
        <a:buFont typeface="Arial" panose="020B0604020202020204" pitchFamily="34" charset="0"/>
        <a:buChar char="•"/>
        <a:defRPr sz="2929" kern="1200">
          <a:solidFill>
            <a:schemeClr val="tx1"/>
          </a:solidFill>
          <a:latin typeface="+mn-lt"/>
          <a:ea typeface="+mn-ea"/>
          <a:cs typeface="+mn-cs"/>
        </a:defRPr>
      </a:lvl8pPr>
      <a:lvl9pPr marL="6323236" indent="-371955" algn="l" defTabSz="1487820" rtl="0" eaLnBrk="1" latinLnBrk="0" hangingPunct="1">
        <a:lnSpc>
          <a:spcPct val="90000"/>
        </a:lnSpc>
        <a:spcBef>
          <a:spcPts val="814"/>
        </a:spcBef>
        <a:buFont typeface="Arial" panose="020B0604020202020204" pitchFamily="34" charset="0"/>
        <a:buChar char="•"/>
        <a:defRPr sz="292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87820" rtl="0" eaLnBrk="1" latinLnBrk="0" hangingPunct="1">
        <a:defRPr sz="2929" kern="1200">
          <a:solidFill>
            <a:schemeClr val="tx1"/>
          </a:solidFill>
          <a:latin typeface="+mn-lt"/>
          <a:ea typeface="+mn-ea"/>
          <a:cs typeface="+mn-cs"/>
        </a:defRPr>
      </a:lvl1pPr>
      <a:lvl2pPr marL="743910" algn="l" defTabSz="1487820" rtl="0" eaLnBrk="1" latinLnBrk="0" hangingPunct="1">
        <a:defRPr sz="2929" kern="1200">
          <a:solidFill>
            <a:schemeClr val="tx1"/>
          </a:solidFill>
          <a:latin typeface="+mn-lt"/>
          <a:ea typeface="+mn-ea"/>
          <a:cs typeface="+mn-cs"/>
        </a:defRPr>
      </a:lvl2pPr>
      <a:lvl3pPr marL="1487820" algn="l" defTabSz="1487820" rtl="0" eaLnBrk="1" latinLnBrk="0" hangingPunct="1">
        <a:defRPr sz="2929" kern="1200">
          <a:solidFill>
            <a:schemeClr val="tx1"/>
          </a:solidFill>
          <a:latin typeface="+mn-lt"/>
          <a:ea typeface="+mn-ea"/>
          <a:cs typeface="+mn-cs"/>
        </a:defRPr>
      </a:lvl3pPr>
      <a:lvl4pPr marL="2231730" algn="l" defTabSz="1487820" rtl="0" eaLnBrk="1" latinLnBrk="0" hangingPunct="1">
        <a:defRPr sz="2929" kern="1200">
          <a:solidFill>
            <a:schemeClr val="tx1"/>
          </a:solidFill>
          <a:latin typeface="+mn-lt"/>
          <a:ea typeface="+mn-ea"/>
          <a:cs typeface="+mn-cs"/>
        </a:defRPr>
      </a:lvl4pPr>
      <a:lvl5pPr marL="2975640" algn="l" defTabSz="1487820" rtl="0" eaLnBrk="1" latinLnBrk="0" hangingPunct="1">
        <a:defRPr sz="2929" kern="1200">
          <a:solidFill>
            <a:schemeClr val="tx1"/>
          </a:solidFill>
          <a:latin typeface="+mn-lt"/>
          <a:ea typeface="+mn-ea"/>
          <a:cs typeface="+mn-cs"/>
        </a:defRPr>
      </a:lvl5pPr>
      <a:lvl6pPr marL="3719551" algn="l" defTabSz="1487820" rtl="0" eaLnBrk="1" latinLnBrk="0" hangingPunct="1">
        <a:defRPr sz="2929" kern="1200">
          <a:solidFill>
            <a:schemeClr val="tx1"/>
          </a:solidFill>
          <a:latin typeface="+mn-lt"/>
          <a:ea typeface="+mn-ea"/>
          <a:cs typeface="+mn-cs"/>
        </a:defRPr>
      </a:lvl6pPr>
      <a:lvl7pPr marL="4463461" algn="l" defTabSz="1487820" rtl="0" eaLnBrk="1" latinLnBrk="0" hangingPunct="1">
        <a:defRPr sz="2929" kern="1200">
          <a:solidFill>
            <a:schemeClr val="tx1"/>
          </a:solidFill>
          <a:latin typeface="+mn-lt"/>
          <a:ea typeface="+mn-ea"/>
          <a:cs typeface="+mn-cs"/>
        </a:defRPr>
      </a:lvl7pPr>
      <a:lvl8pPr marL="5207371" algn="l" defTabSz="1487820" rtl="0" eaLnBrk="1" latinLnBrk="0" hangingPunct="1">
        <a:defRPr sz="2929" kern="1200">
          <a:solidFill>
            <a:schemeClr val="tx1"/>
          </a:solidFill>
          <a:latin typeface="+mn-lt"/>
          <a:ea typeface="+mn-ea"/>
          <a:cs typeface="+mn-cs"/>
        </a:defRPr>
      </a:lvl8pPr>
      <a:lvl9pPr marL="5951281" algn="l" defTabSz="1487820" rtl="0" eaLnBrk="1" latinLnBrk="0" hangingPunct="1">
        <a:defRPr sz="292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Рисунок 2">
            <a:extLst>
              <a:ext uri="{FF2B5EF4-FFF2-40B4-BE49-F238E27FC236}">
                <a16:creationId xmlns:a16="http://schemas.microsoft.com/office/drawing/2014/main" id="{D06FFDC8-226F-E88D-85CD-F8918A4FD66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116"/>
          <a:stretch/>
        </p:blipFill>
        <p:spPr>
          <a:xfrm>
            <a:off x="512932" y="827201"/>
            <a:ext cx="6699239" cy="3784768"/>
          </a:xfrm>
          <a:prstGeom prst="rect">
            <a:avLst/>
          </a:prstGeom>
        </p:spPr>
      </p:pic>
      <p:pic>
        <p:nvPicPr>
          <p:cNvPr id="5" name="Рисунок 4">
            <a:extLst>
              <a:ext uri="{FF2B5EF4-FFF2-40B4-BE49-F238E27FC236}">
                <a16:creationId xmlns:a16="http://schemas.microsoft.com/office/drawing/2014/main" id="{C31F01E0-E46C-4051-FDD9-233CC2D3B2A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287"/>
          <a:stretch/>
        </p:blipFill>
        <p:spPr>
          <a:xfrm>
            <a:off x="7816886" y="827201"/>
            <a:ext cx="6699239" cy="3784768"/>
          </a:xfrm>
          <a:prstGeom prst="rect">
            <a:avLst/>
          </a:prstGeom>
        </p:spPr>
      </p:pic>
      <p:pic>
        <p:nvPicPr>
          <p:cNvPr id="7" name="Рисунок 6">
            <a:extLst>
              <a:ext uri="{FF2B5EF4-FFF2-40B4-BE49-F238E27FC236}">
                <a16:creationId xmlns:a16="http://schemas.microsoft.com/office/drawing/2014/main" id="{81315B44-E650-610C-3100-AE8E3A872F1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934" y="5391555"/>
            <a:ext cx="8360613" cy="403025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C137C0F-937B-65C3-7187-7F8B883F217A}"/>
              </a:ext>
            </a:extLst>
          </p:cNvPr>
          <p:cNvSpPr txBox="1"/>
          <p:nvPr/>
        </p:nvSpPr>
        <p:spPr>
          <a:xfrm>
            <a:off x="426673" y="9623451"/>
            <a:ext cx="1549912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olcano plots</a:t>
            </a:r>
            <a:r>
              <a:rPr lang="ru-RU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DEGs of spermatogonia and spermatocytes clusters</a:t>
            </a:r>
            <a:r>
              <a:rPr lang="ru-RU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ru-RU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А</a:t>
            </a:r>
            <a:r>
              <a:rPr lang="ru-RU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toli</a:t>
            </a:r>
            <a:r>
              <a:rPr lang="ru-RU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ru-RU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Leydig cells</a:t>
            </a:r>
            <a:r>
              <a:rPr lang="ru-RU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ru-RU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phs were made by</a:t>
            </a:r>
            <a:r>
              <a:rPr lang="ru-RU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phPad Prism.</a:t>
            </a:r>
            <a:endParaRPr lang="ru-RU" sz="101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A1F94EE-9770-B0E9-BBE8-D5C6878CEE12}"/>
              </a:ext>
            </a:extLst>
          </p:cNvPr>
          <p:cNvSpPr txBox="1"/>
          <p:nvPr/>
        </p:nvSpPr>
        <p:spPr>
          <a:xfrm>
            <a:off x="652556" y="179391"/>
            <a:ext cx="6525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E932C82-713E-0807-D253-C4343B2D7B2A}"/>
              </a:ext>
            </a:extLst>
          </p:cNvPr>
          <p:cNvSpPr txBox="1"/>
          <p:nvPr/>
        </p:nvSpPr>
        <p:spPr>
          <a:xfrm>
            <a:off x="651059" y="4735783"/>
            <a:ext cx="6525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604A282-FF47-8D3C-5749-03BA1C2BF69E}"/>
              </a:ext>
            </a:extLst>
          </p:cNvPr>
          <p:cNvSpPr txBox="1"/>
          <p:nvPr/>
        </p:nvSpPr>
        <p:spPr>
          <a:xfrm>
            <a:off x="7629529" y="179393"/>
            <a:ext cx="6540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900718692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56</TotalTime>
  <Words>35</Words>
  <Application>Microsoft Office PowerPoint</Application>
  <PresentationFormat>Произвольный</PresentationFormat>
  <Paragraphs>4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4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Тема Office</vt:lpstr>
      <vt:lpstr>Презентация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Катерина Варламова</dc:creator>
  <cp:lastModifiedBy>Katherin V</cp:lastModifiedBy>
  <cp:revision>45</cp:revision>
  <dcterms:created xsi:type="dcterms:W3CDTF">2023-05-24T11:57:50Z</dcterms:created>
  <dcterms:modified xsi:type="dcterms:W3CDTF">2025-01-22T14:10:16Z</dcterms:modified>
</cp:coreProperties>
</file>